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102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err="1"/>
              <a:t>qRT-PCR,colonies</a:t>
            </a:r>
            <a:r>
              <a:rPr lang="en-US" dirty="0"/>
              <a:t> screening, </a:t>
            </a:r>
            <a:r>
              <a:rPr lang="en-US" dirty="0" smtClean="0"/>
              <a:t>T47d-DLC1, </a:t>
            </a:r>
            <a:r>
              <a:rPr lang="en-US" dirty="0"/>
              <a:t>plate1, </a:t>
            </a:r>
          </a:p>
        </c:rich>
      </c:tx>
      <c:layout>
        <c:manualLayout>
          <c:xMode val="edge"/>
          <c:yMode val="edge"/>
          <c:x val="0.26403105861767279"/>
          <c:y val="4.49711143341675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0688219261053907E-2"/>
          <c:y val="0.18860594478886594"/>
          <c:w val="0.93755964398680935"/>
          <c:h val="0.684934173112738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M$15:$M$27</c:f>
              <c:strCache>
                <c:ptCount val="13"/>
                <c:pt idx="0">
                  <c:v>T47D DLC1#1</c:v>
                </c:pt>
                <c:pt idx="3">
                  <c:v>T47D DLC1#2</c:v>
                </c:pt>
                <c:pt idx="6">
                  <c:v>T47D DLC1#3</c:v>
                </c:pt>
                <c:pt idx="9">
                  <c:v>T47D DLC1#4</c:v>
                </c:pt>
                <c:pt idx="12">
                  <c:v>T47D DLC1#5</c:v>
                </c:pt>
              </c:strCache>
            </c:strRef>
          </c:cat>
          <c:val>
            <c:numRef>
              <c:f>Sheet2!$N$15:$N$27</c:f>
              <c:numCache>
                <c:formatCode>General</c:formatCode>
                <c:ptCount val="13"/>
                <c:pt idx="0" formatCode="0.0">
                  <c:v>1.8601264096096133</c:v>
                </c:pt>
                <c:pt idx="3" formatCode="0.0">
                  <c:v>1.4185581913775276</c:v>
                </c:pt>
                <c:pt idx="6" formatCode="0.0">
                  <c:v>1.7597302975995086</c:v>
                </c:pt>
                <c:pt idx="9" formatCode="0.0">
                  <c:v>2.5107992214232646</c:v>
                </c:pt>
                <c:pt idx="12" formatCode="0.0">
                  <c:v>1.8983223577945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95-482C-9237-D356BDC0F0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144043552"/>
        <c:axId val="-1144045728"/>
      </c:barChart>
      <c:catAx>
        <c:axId val="-1144043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44045728"/>
        <c:crosses val="autoZero"/>
        <c:auto val="1"/>
        <c:lblAlgn val="ctr"/>
        <c:lblOffset val="100"/>
        <c:noMultiLvlLbl val="0"/>
      </c:catAx>
      <c:valAx>
        <c:axId val="-1144045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 over vect.#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44043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err="1"/>
              <a:t>qRT</a:t>
            </a:r>
            <a:r>
              <a:rPr lang="en-US" dirty="0"/>
              <a:t>-PCR, plate2,T46D-DLC1 colonies screening,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M$3:$M$27</c:f>
              <c:strCache>
                <c:ptCount val="25"/>
                <c:pt idx="0">
                  <c:v>T47D DLC1#6</c:v>
                </c:pt>
                <c:pt idx="3">
                  <c:v>T47D DLC1#7</c:v>
                </c:pt>
                <c:pt idx="6">
                  <c:v>T47D DLC1#8</c:v>
                </c:pt>
                <c:pt idx="9">
                  <c:v>T47D DLC1#9</c:v>
                </c:pt>
                <c:pt idx="12">
                  <c:v>T47D DLC1#10</c:v>
                </c:pt>
                <c:pt idx="15">
                  <c:v>T47D DLC1#11</c:v>
                </c:pt>
                <c:pt idx="18">
                  <c:v>T47D DLC1#12</c:v>
                </c:pt>
                <c:pt idx="21">
                  <c:v>T47D DLC1#13</c:v>
                </c:pt>
                <c:pt idx="24">
                  <c:v>T47D DLC1#14</c:v>
                </c:pt>
              </c:strCache>
            </c:strRef>
          </c:cat>
          <c:val>
            <c:numRef>
              <c:f>Sheet2!$N$3:$N$27</c:f>
              <c:numCache>
                <c:formatCode>General</c:formatCode>
                <c:ptCount val="25"/>
                <c:pt idx="0" formatCode="0.0">
                  <c:v>2.272874459203742</c:v>
                </c:pt>
                <c:pt idx="3" formatCode="0.0">
                  <c:v>2.5035044155953132</c:v>
                </c:pt>
                <c:pt idx="6" formatCode="0.00000000000000">
                  <c:v>2.0937492398341941</c:v>
                </c:pt>
                <c:pt idx="9" formatCode="0.00000000000000">
                  <c:v>2.122608547617717</c:v>
                </c:pt>
                <c:pt idx="12" formatCode="0.00000000000000">
                  <c:v>2.6752023131911207</c:v>
                </c:pt>
                <c:pt idx="15" formatCode="0.00000000000000">
                  <c:v>1.0056992932597737</c:v>
                </c:pt>
                <c:pt idx="18" formatCode="0.00000000000000">
                  <c:v>1.4899896748754413</c:v>
                </c:pt>
                <c:pt idx="21" formatCode="0.00000000000000">
                  <c:v>8.5580394735163772</c:v>
                </c:pt>
                <c:pt idx="24" formatCode="0.00000000000000">
                  <c:v>2.82249103771294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E6-4A15-A229-602A4822CA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29654080"/>
        <c:axId val="-1029657888"/>
      </c:barChart>
      <c:catAx>
        <c:axId val="-1029654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29657888"/>
        <c:crosses val="autoZero"/>
        <c:auto val="1"/>
        <c:lblAlgn val="ctr"/>
        <c:lblOffset val="100"/>
        <c:noMultiLvlLbl val="0"/>
      </c:catAx>
      <c:valAx>
        <c:axId val="-1029657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fold</a:t>
                </a:r>
                <a:r>
                  <a:rPr lang="en-US" baseline="0" dirty="0" smtClean="0"/>
                  <a:t> over vector#1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29654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qRT-PCR,plate3, T47D-DLC1 colonies </a:t>
            </a:r>
            <a:r>
              <a:rPr lang="en-US" dirty="0" smtClean="0"/>
              <a:t>screening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L$3:$L$27</c:f>
              <c:strCache>
                <c:ptCount val="25"/>
                <c:pt idx="0">
                  <c:v>T47D DLC1 #15</c:v>
                </c:pt>
                <c:pt idx="3">
                  <c:v>T47D DLC1 #16</c:v>
                </c:pt>
                <c:pt idx="6">
                  <c:v>T47D DLC1 #17</c:v>
                </c:pt>
                <c:pt idx="9">
                  <c:v>T47D DLC1 #18</c:v>
                </c:pt>
                <c:pt idx="12">
                  <c:v>T47D DLC1 #19</c:v>
                </c:pt>
                <c:pt idx="15">
                  <c:v>T47D DLC1 #20</c:v>
                </c:pt>
                <c:pt idx="18">
                  <c:v>T47D DLC1 #21</c:v>
                </c:pt>
                <c:pt idx="21">
                  <c:v>T47D DLC1 #22</c:v>
                </c:pt>
                <c:pt idx="24">
                  <c:v>T47D DLC1 #23</c:v>
                </c:pt>
              </c:strCache>
            </c:strRef>
          </c:cat>
          <c:val>
            <c:numRef>
              <c:f>Sheet2!$M$3:$M$27</c:f>
              <c:numCache>
                <c:formatCode>General</c:formatCode>
                <c:ptCount val="25"/>
                <c:pt idx="0" formatCode="0.0">
                  <c:v>3.4024988324280958</c:v>
                </c:pt>
                <c:pt idx="3" formatCode="0.0">
                  <c:v>1.2510036510408389</c:v>
                </c:pt>
                <c:pt idx="6" formatCode="0.0">
                  <c:v>2.4061106677285187</c:v>
                </c:pt>
                <c:pt idx="9" formatCode="0.0">
                  <c:v>2.749037651828059</c:v>
                </c:pt>
                <c:pt idx="12" formatCode="0.0">
                  <c:v>1.2562639936165161</c:v>
                </c:pt>
                <c:pt idx="15" formatCode="0.0">
                  <c:v>1.6403784167483004</c:v>
                </c:pt>
                <c:pt idx="18" formatCode="0.0">
                  <c:v>1.3315900542230046</c:v>
                </c:pt>
                <c:pt idx="21" formatCode="0.0">
                  <c:v>2.8958703229597997</c:v>
                </c:pt>
                <c:pt idx="24" formatCode="0.0">
                  <c:v>2.07735819665949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AA-47F1-AA66-13B55616C8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144047360"/>
        <c:axId val="-1144044640"/>
      </c:barChart>
      <c:catAx>
        <c:axId val="-1144047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44044640"/>
        <c:crosses val="autoZero"/>
        <c:auto val="1"/>
        <c:lblAlgn val="ctr"/>
        <c:lblOffset val="100"/>
        <c:noMultiLvlLbl val="0"/>
      </c:catAx>
      <c:valAx>
        <c:axId val="-1144044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Fold over vector#1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44047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851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78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43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407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831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56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370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054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921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06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03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A5EFD-8FAA-4EDE-BF3D-B5D90AA3ADDE}" type="datetimeFigureOut">
              <a:rPr lang="en-US" smtClean="0"/>
              <a:t>5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42D31-E61F-4DE7-A5A3-A27914298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6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5175378"/>
              </p:ext>
            </p:extLst>
          </p:nvPr>
        </p:nvGraphicFramePr>
        <p:xfrm>
          <a:off x="304800" y="1110360"/>
          <a:ext cx="11887200" cy="3418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729673" y="59112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5778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8558795"/>
              </p:ext>
            </p:extLst>
          </p:nvPr>
        </p:nvGraphicFramePr>
        <p:xfrm>
          <a:off x="263612" y="1180008"/>
          <a:ext cx="11928388" cy="33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37309" y="45258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9567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9258581"/>
              </p:ext>
            </p:extLst>
          </p:nvPr>
        </p:nvGraphicFramePr>
        <p:xfrm>
          <a:off x="247135" y="1141970"/>
          <a:ext cx="11944865" cy="3713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91127" y="38792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9892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32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eth, Edyta</dc:creator>
  <cp:lastModifiedBy>Polar, Yesim</cp:lastModifiedBy>
  <cp:revision>9</cp:revision>
  <dcterms:created xsi:type="dcterms:W3CDTF">2015-10-07T13:20:32Z</dcterms:created>
  <dcterms:modified xsi:type="dcterms:W3CDTF">2018-05-04T00:21:54Z</dcterms:modified>
</cp:coreProperties>
</file>